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D22F05F-A1A9-4940-8D90-6DD69F4CA72A}" v="1" dt="2025-11-05T13:28:07.97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6" autoAdjust="0"/>
    <p:restoredTop sz="94660"/>
  </p:normalViewPr>
  <p:slideViewPr>
    <p:cSldViewPr snapToGrid="0">
      <p:cViewPr varScale="1">
        <p:scale>
          <a:sx n="88" d="100"/>
          <a:sy n="88" d="100"/>
        </p:scale>
        <p:origin x="210" y="5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riève Houle" userId="84c369079bb2ec68" providerId="LiveId" clId="{6D22F05F-A1A9-4940-8D90-6DD69F4CA72A}"/>
    <pc:docChg chg="modSld">
      <pc:chgData name="Mariève Houle" userId="84c369079bb2ec68" providerId="LiveId" clId="{6D22F05F-A1A9-4940-8D90-6DD69F4CA72A}" dt="2025-11-05T13:28:10.706" v="30" actId="1076"/>
      <pc:docMkLst>
        <pc:docMk/>
      </pc:docMkLst>
      <pc:sldChg chg="addSp modSp mod">
        <pc:chgData name="Mariève Houle" userId="84c369079bb2ec68" providerId="LiveId" clId="{6D22F05F-A1A9-4940-8D90-6DD69F4CA72A}" dt="2025-11-05T13:28:10.706" v="30" actId="1076"/>
        <pc:sldMkLst>
          <pc:docMk/>
          <pc:sldMk cId="3116359780" sldId="256"/>
        </pc:sldMkLst>
        <pc:spChg chg="mod">
          <ac:chgData name="Mariève Houle" userId="84c369079bb2ec68" providerId="LiveId" clId="{6D22F05F-A1A9-4940-8D90-6DD69F4CA72A}" dt="2025-11-05T13:28:07.975" v="29" actId="164"/>
          <ac:spMkLst>
            <pc:docMk/>
            <pc:sldMk cId="3116359780" sldId="256"/>
            <ac:spMk id="2" creationId="{E3D287A9-47BC-AD92-C7F2-8B174BD73663}"/>
          </ac:spMkLst>
        </pc:spChg>
        <pc:spChg chg="add mod">
          <ac:chgData name="Mariève Houle" userId="84c369079bb2ec68" providerId="LiveId" clId="{6D22F05F-A1A9-4940-8D90-6DD69F4CA72A}" dt="2025-11-05T13:27:59.274" v="28" actId="1076"/>
          <ac:spMkLst>
            <pc:docMk/>
            <pc:sldMk cId="3116359780" sldId="256"/>
            <ac:spMk id="4" creationId="{C36C36BF-19FF-EBAB-017A-3ACD93A20EE9}"/>
          </ac:spMkLst>
        </pc:spChg>
        <pc:spChg chg="mod">
          <ac:chgData name="Mariève Houle" userId="84c369079bb2ec68" providerId="LiveId" clId="{6D22F05F-A1A9-4940-8D90-6DD69F4CA72A}" dt="2025-11-05T13:28:07.975" v="29" actId="164"/>
          <ac:spMkLst>
            <pc:docMk/>
            <pc:sldMk cId="3116359780" sldId="256"/>
            <ac:spMk id="15" creationId="{3FD7D212-BD64-C6A5-19CD-3F070A5B24F0}"/>
          </ac:spMkLst>
        </pc:spChg>
        <pc:spChg chg="mod">
          <ac:chgData name="Mariève Houle" userId="84c369079bb2ec68" providerId="LiveId" clId="{6D22F05F-A1A9-4940-8D90-6DD69F4CA72A}" dt="2025-11-05T13:28:07.975" v="29" actId="164"/>
          <ac:spMkLst>
            <pc:docMk/>
            <pc:sldMk cId="3116359780" sldId="256"/>
            <ac:spMk id="22" creationId="{A0DC3FD0-4611-5D6A-9D6C-65BE5676339F}"/>
          </ac:spMkLst>
        </pc:spChg>
        <pc:spChg chg="mod">
          <ac:chgData name="Mariève Houle" userId="84c369079bb2ec68" providerId="LiveId" clId="{6D22F05F-A1A9-4940-8D90-6DD69F4CA72A}" dt="2025-11-05T13:28:07.975" v="29" actId="164"/>
          <ac:spMkLst>
            <pc:docMk/>
            <pc:sldMk cId="3116359780" sldId="256"/>
            <ac:spMk id="26" creationId="{D752B9C6-1878-E434-3F3F-80D36F9D76C5}"/>
          </ac:spMkLst>
        </pc:spChg>
        <pc:spChg chg="mod">
          <ac:chgData name="Mariève Houle" userId="84c369079bb2ec68" providerId="LiveId" clId="{6D22F05F-A1A9-4940-8D90-6DD69F4CA72A}" dt="2025-11-05T13:28:07.975" v="29" actId="164"/>
          <ac:spMkLst>
            <pc:docMk/>
            <pc:sldMk cId="3116359780" sldId="256"/>
            <ac:spMk id="30" creationId="{389FA323-2E85-2570-3A43-391AA24A88E0}"/>
          </ac:spMkLst>
        </pc:spChg>
        <pc:spChg chg="mod">
          <ac:chgData name="Mariève Houle" userId="84c369079bb2ec68" providerId="LiveId" clId="{6D22F05F-A1A9-4940-8D90-6DD69F4CA72A}" dt="2025-11-05T13:28:07.975" v="29" actId="164"/>
          <ac:spMkLst>
            <pc:docMk/>
            <pc:sldMk cId="3116359780" sldId="256"/>
            <ac:spMk id="36" creationId="{20D86CFE-8BA8-0AC9-29DF-37A4791D4818}"/>
          </ac:spMkLst>
        </pc:spChg>
        <pc:spChg chg="mod">
          <ac:chgData name="Mariève Houle" userId="84c369079bb2ec68" providerId="LiveId" clId="{6D22F05F-A1A9-4940-8D90-6DD69F4CA72A}" dt="2025-11-05T13:28:07.975" v="29" actId="164"/>
          <ac:spMkLst>
            <pc:docMk/>
            <pc:sldMk cId="3116359780" sldId="256"/>
            <ac:spMk id="37" creationId="{62951A4F-EE9B-22C3-9509-B727748437C7}"/>
          </ac:spMkLst>
        </pc:spChg>
        <pc:spChg chg="mod">
          <ac:chgData name="Mariève Houle" userId="84c369079bb2ec68" providerId="LiveId" clId="{6D22F05F-A1A9-4940-8D90-6DD69F4CA72A}" dt="2025-11-05T13:28:07.975" v="29" actId="164"/>
          <ac:spMkLst>
            <pc:docMk/>
            <pc:sldMk cId="3116359780" sldId="256"/>
            <ac:spMk id="41" creationId="{0AE13900-825B-5B46-1DD8-1A41696E8CA4}"/>
          </ac:spMkLst>
        </pc:spChg>
        <pc:spChg chg="mod">
          <ac:chgData name="Mariève Houle" userId="84c369079bb2ec68" providerId="LiveId" clId="{6D22F05F-A1A9-4940-8D90-6DD69F4CA72A}" dt="2025-11-05T13:28:07.975" v="29" actId="164"/>
          <ac:spMkLst>
            <pc:docMk/>
            <pc:sldMk cId="3116359780" sldId="256"/>
            <ac:spMk id="44" creationId="{95C7F27C-7B89-84A1-BAD2-683FDAE10C12}"/>
          </ac:spMkLst>
        </pc:spChg>
        <pc:spChg chg="mod">
          <ac:chgData name="Mariève Houle" userId="84c369079bb2ec68" providerId="LiveId" clId="{6D22F05F-A1A9-4940-8D90-6DD69F4CA72A}" dt="2025-11-05T13:28:07.975" v="29" actId="164"/>
          <ac:spMkLst>
            <pc:docMk/>
            <pc:sldMk cId="3116359780" sldId="256"/>
            <ac:spMk id="49" creationId="{0B9A90E1-A6D8-5B33-B05B-B8FDCAFDD579}"/>
          </ac:spMkLst>
        </pc:spChg>
        <pc:grpChg chg="mod">
          <ac:chgData name="Mariève Houle" userId="84c369079bb2ec68" providerId="LiveId" clId="{6D22F05F-A1A9-4940-8D90-6DD69F4CA72A}" dt="2025-11-05T13:28:10.706" v="30" actId="1076"/>
          <ac:grpSpMkLst>
            <pc:docMk/>
            <pc:sldMk cId="3116359780" sldId="256"/>
            <ac:grpSpMk id="5" creationId="{E2A0B11C-3AEA-8AD0-682B-7C856B98D32A}"/>
          </ac:grpSpMkLst>
        </pc:grpChg>
      </pc:sldChg>
    </pc:docChg>
  </pc:docChgLst>
  <pc:docChgLst>
    <pc:chgData name="Mariève Houle" userId="84c369079bb2ec68" providerId="LiveId" clId="{8E3EC0FF-70B9-4D31-A0E9-288DAD5C8DEB}"/>
    <pc:docChg chg="modSld">
      <pc:chgData name="Mariève Houle" userId="84c369079bb2ec68" providerId="LiveId" clId="{8E3EC0FF-70B9-4D31-A0E9-288DAD5C8DEB}" dt="2025-09-30T11:20:18.471" v="144" actId="1035"/>
      <pc:docMkLst>
        <pc:docMk/>
      </pc:docMkLst>
      <pc:sldChg chg="addSp modSp mod">
        <pc:chgData name="Mariève Houle" userId="84c369079bb2ec68" providerId="LiveId" clId="{8E3EC0FF-70B9-4D31-A0E9-288DAD5C8DEB}" dt="2025-09-30T11:20:18.471" v="144" actId="1035"/>
        <pc:sldMkLst>
          <pc:docMk/>
          <pc:sldMk cId="3116359780" sldId="256"/>
        </pc:sldMkLst>
        <pc:spChg chg="add mod">
          <ac:chgData name="Mariève Houle" userId="84c369079bb2ec68" providerId="LiveId" clId="{8E3EC0FF-70B9-4D31-A0E9-288DAD5C8DEB}" dt="2025-09-30T11:20:18.471" v="144" actId="1035"/>
          <ac:spMkLst>
            <pc:docMk/>
            <pc:sldMk cId="3116359780" sldId="256"/>
            <ac:spMk id="2" creationId="{E3D287A9-47BC-AD92-C7F2-8B174BD73663}"/>
          </ac:spMkLst>
        </pc:spChg>
        <pc:spChg chg="mod">
          <ac:chgData name="Mariève Houle" userId="84c369079bb2ec68" providerId="LiveId" clId="{8E3EC0FF-70B9-4D31-A0E9-288DAD5C8DEB}" dt="2025-09-30T11:20:18.471" v="144" actId="1035"/>
          <ac:spMkLst>
            <pc:docMk/>
            <pc:sldMk cId="3116359780" sldId="256"/>
            <ac:spMk id="34" creationId="{957DC773-0491-0CAC-3163-1E6B0987FD9D}"/>
          </ac:spMkLst>
        </pc:spChg>
        <pc:spChg chg="mod">
          <ac:chgData name="Mariève Houle" userId="84c369079bb2ec68" providerId="LiveId" clId="{8E3EC0FF-70B9-4D31-A0E9-288DAD5C8DEB}" dt="2025-09-30T11:20:18.471" v="144" actId="1035"/>
          <ac:spMkLst>
            <pc:docMk/>
            <pc:sldMk cId="3116359780" sldId="256"/>
            <ac:spMk id="35" creationId="{D918D780-B2B6-2A75-A898-38C0BAB11E67}"/>
          </ac:spMkLst>
        </pc:spChg>
        <pc:spChg chg="mod">
          <ac:chgData name="Mariève Houle" userId="84c369079bb2ec68" providerId="LiveId" clId="{8E3EC0FF-70B9-4D31-A0E9-288DAD5C8DEB}" dt="2025-09-30T11:20:18.471" v="144" actId="1035"/>
          <ac:spMkLst>
            <pc:docMk/>
            <pc:sldMk cId="3116359780" sldId="256"/>
            <ac:spMk id="36" creationId="{20D86CFE-8BA8-0AC9-29DF-37A4791D4818}"/>
          </ac:spMkLst>
        </pc:spChg>
        <pc:spChg chg="mod">
          <ac:chgData name="Mariève Houle" userId="84c369079bb2ec68" providerId="LiveId" clId="{8E3EC0FF-70B9-4D31-A0E9-288DAD5C8DEB}" dt="2025-09-30T11:20:18.471" v="144" actId="1035"/>
          <ac:spMkLst>
            <pc:docMk/>
            <pc:sldMk cId="3116359780" sldId="256"/>
            <ac:spMk id="38" creationId="{ACC82BFB-ED40-0E5D-ED4A-2620FED96B4B}"/>
          </ac:spMkLst>
        </pc:spChg>
        <pc:spChg chg="mod">
          <ac:chgData name="Mariève Houle" userId="84c369079bb2ec68" providerId="LiveId" clId="{8E3EC0FF-70B9-4D31-A0E9-288DAD5C8DEB}" dt="2025-09-30T11:20:18.471" v="144" actId="1035"/>
          <ac:spMkLst>
            <pc:docMk/>
            <pc:sldMk cId="3116359780" sldId="256"/>
            <ac:spMk id="39" creationId="{A41B2ED6-0A1E-06CC-1F96-BE3D7802710D}"/>
          </ac:spMkLst>
        </pc:spChg>
        <pc:spChg chg="mod">
          <ac:chgData name="Mariève Houle" userId="84c369079bb2ec68" providerId="LiveId" clId="{8E3EC0FF-70B9-4D31-A0E9-288DAD5C8DEB}" dt="2025-09-30T11:20:18.471" v="144" actId="1035"/>
          <ac:spMkLst>
            <pc:docMk/>
            <pc:sldMk cId="3116359780" sldId="256"/>
            <ac:spMk id="41" creationId="{0AE13900-825B-5B46-1DD8-1A41696E8CA4}"/>
          </ac:spMkLst>
        </pc:spChg>
        <pc:spChg chg="mod">
          <ac:chgData name="Mariève Houle" userId="84c369079bb2ec68" providerId="LiveId" clId="{8E3EC0FF-70B9-4D31-A0E9-288DAD5C8DEB}" dt="2025-09-30T11:20:18.471" v="144" actId="1035"/>
          <ac:spMkLst>
            <pc:docMk/>
            <pc:sldMk cId="3116359780" sldId="256"/>
            <ac:spMk id="46" creationId="{9ACCD3B3-723B-82A7-9FE4-2A58A64FAE3C}"/>
          </ac:spMkLst>
        </pc:spChg>
        <pc:spChg chg="mod">
          <ac:chgData name="Mariève Houle" userId="84c369079bb2ec68" providerId="LiveId" clId="{8E3EC0FF-70B9-4D31-A0E9-288DAD5C8DEB}" dt="2025-09-30T11:20:18.471" v="144" actId="1035"/>
          <ac:spMkLst>
            <pc:docMk/>
            <pc:sldMk cId="3116359780" sldId="256"/>
            <ac:spMk id="47" creationId="{9994EED0-18A6-F433-E8B4-EB1F1354BBBA}"/>
          </ac:spMkLst>
        </pc:spChg>
        <pc:spChg chg="mod">
          <ac:chgData name="Mariève Houle" userId="84c369079bb2ec68" providerId="LiveId" clId="{8E3EC0FF-70B9-4D31-A0E9-288DAD5C8DEB}" dt="2025-09-30T11:20:18.471" v="144" actId="1035"/>
          <ac:spMkLst>
            <pc:docMk/>
            <pc:sldMk cId="3116359780" sldId="256"/>
            <ac:spMk id="48" creationId="{14DCFC1D-95D9-99A7-6FC1-CABF65021BDA}"/>
          </ac:spMkLst>
        </pc:spChg>
        <pc:spChg chg="mod">
          <ac:chgData name="Mariève Houle" userId="84c369079bb2ec68" providerId="LiveId" clId="{8E3EC0FF-70B9-4D31-A0E9-288DAD5C8DEB}" dt="2025-09-30T08:09:19.297" v="69" actId="1076"/>
          <ac:spMkLst>
            <pc:docMk/>
            <pc:sldMk cId="3116359780" sldId="256"/>
            <ac:spMk id="49" creationId="{0B9A90E1-A6D8-5B33-B05B-B8FDCAFDD579}"/>
          </ac:spMkLst>
        </pc:spChg>
        <pc:spChg chg="mod">
          <ac:chgData name="Mariève Houle" userId="84c369079bb2ec68" providerId="LiveId" clId="{8E3EC0FF-70B9-4D31-A0E9-288DAD5C8DEB}" dt="2025-09-30T11:02:34.424" v="76" actId="1076"/>
          <ac:spMkLst>
            <pc:docMk/>
            <pc:sldMk cId="3116359780" sldId="256"/>
            <ac:spMk id="50" creationId="{22789C7F-7F89-1FE7-B5A4-A789005AD2EB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48BE805-133E-EAAB-F72F-43D74EC30E4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FFED64EF-97DF-F0E7-DECC-1CE69884292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fr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0A3D9BD-19F9-9A72-5FEB-1ED40903AC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F99FF6-5FB5-403B-896B-059DB143E415}" type="datetimeFigureOut">
              <a:rPr lang="fr-CA" smtClean="0"/>
              <a:t>2025-11-05</a:t>
            </a:fld>
            <a:endParaRPr lang="fr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CD6FE3B-4221-75C7-BB8C-D63B5BF094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2D4A7EF-C05A-0B21-A91C-F6A3F3CE59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27986-6FB6-4726-8033-6EA91535989C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8684002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61815D9-EB48-E786-BA44-412A283979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5EB2D6A3-CA8C-2FD3-147E-769F55748B5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92BCEBC-D65B-A1EC-9517-B10DDAAF5B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F99FF6-5FB5-403B-896B-059DB143E415}" type="datetimeFigureOut">
              <a:rPr lang="fr-CA" smtClean="0"/>
              <a:t>2025-11-05</a:t>
            </a:fld>
            <a:endParaRPr lang="fr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7ED94E8-3C44-5C23-17F5-4A7BD0C78C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615C5CB-A66C-751B-AC4B-8DE3EA0680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27986-6FB6-4726-8033-6EA91535989C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6888409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C6BE37EC-3727-9CB1-0B32-79D3ADDAFBA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ABACA412-166C-E506-620C-50AC18E539E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C3705F8-9F02-12D1-505D-9028BE03E2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F99FF6-5FB5-403B-896B-059DB143E415}" type="datetimeFigureOut">
              <a:rPr lang="fr-CA" smtClean="0"/>
              <a:t>2025-11-05</a:t>
            </a:fld>
            <a:endParaRPr lang="fr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7BD520D-6014-D2EF-BD4A-0BFEC43430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932C37D-828E-CAB6-EA03-746EC736E0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27986-6FB6-4726-8033-6EA91535989C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5521554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71BE2C6-447E-92A5-58D4-90778CC4B7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38AB041-2A5A-B3AC-E393-98810230158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F8A1F6A-7CE2-DEB1-E3DE-42872F1308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F99FF6-5FB5-403B-896B-059DB143E415}" type="datetimeFigureOut">
              <a:rPr lang="fr-CA" smtClean="0"/>
              <a:t>2025-11-05</a:t>
            </a:fld>
            <a:endParaRPr lang="fr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37BD5A0-1F83-8B58-A208-01BF83938E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47533D2-BF8D-C482-F512-EFD92F26A2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27986-6FB6-4726-8033-6EA91535989C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4122331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92C7111-DFEF-FDC1-7868-0F32674E47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2B51F2FF-9943-F4BE-20D5-7C5CB0E97B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BC246B0-0ABB-EAA1-2C3A-371EA8F902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F99FF6-5FB5-403B-896B-059DB143E415}" type="datetimeFigureOut">
              <a:rPr lang="fr-CA" smtClean="0"/>
              <a:t>2025-11-05</a:t>
            </a:fld>
            <a:endParaRPr lang="fr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2ED4F6F-7A41-87F7-2B55-212277F1FE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CC39AFE-C4B7-8398-1277-6E0D3C479E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27986-6FB6-4726-8033-6EA91535989C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0320014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641E9F6-665B-FA38-3D5E-B97F902F20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C0240067-EBE6-6A4F-5710-F9E05FF182C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3218C492-5C3E-6698-DBA3-3262D51039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D03AD68C-F4A8-F7EE-0368-D1BB250F00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F99FF6-5FB5-403B-896B-059DB143E415}" type="datetimeFigureOut">
              <a:rPr lang="fr-CA" smtClean="0"/>
              <a:t>2025-11-05</a:t>
            </a:fld>
            <a:endParaRPr lang="fr-CA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2FD0E366-2FD9-EDA2-244C-502CE60F14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67E9723-DB06-E8C3-67BD-15B619CCDD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27986-6FB6-4726-8033-6EA91535989C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9053453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0DE7EEB-33B5-13CA-EF51-D0F1702C64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07E3A7CB-D262-77CE-B58B-312BC85556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FCC81D32-FA29-9F3D-6617-2EE6F817BC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DBD4AAC3-B18B-2804-9954-57A582108EB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DABAA916-FE35-6F62-8948-1983FDA4DE0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B8985B85-3810-6881-AFCB-90C8F76874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F99FF6-5FB5-403B-896B-059DB143E415}" type="datetimeFigureOut">
              <a:rPr lang="fr-CA" smtClean="0"/>
              <a:t>2025-11-05</a:t>
            </a:fld>
            <a:endParaRPr lang="fr-CA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F280729D-E5FB-E41E-AB22-757FF5B8DE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41E49DCB-EDA6-47CC-BE9D-2E566FB7CB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27986-6FB6-4726-8033-6EA91535989C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8572718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D6D1C9D-DC8D-866E-167D-20A8A288D1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76BC6C29-AB71-D1D2-9EEA-009CB0D1B2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F99FF6-5FB5-403B-896B-059DB143E415}" type="datetimeFigureOut">
              <a:rPr lang="fr-CA" smtClean="0"/>
              <a:t>2025-11-05</a:t>
            </a:fld>
            <a:endParaRPr lang="fr-CA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2A8EEDF2-0D00-1A89-2FB8-E825C6B7DC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4CCDD158-2782-C72A-E549-C3E2B408DC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27986-6FB6-4726-8033-6EA91535989C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9336620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F37615A0-BEF7-9D0A-5614-CADFDE8B8D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F99FF6-5FB5-403B-896B-059DB143E415}" type="datetimeFigureOut">
              <a:rPr lang="fr-CA" smtClean="0"/>
              <a:t>2025-11-05</a:t>
            </a:fld>
            <a:endParaRPr lang="fr-CA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988256DB-C8E7-5B27-F9ED-81F7967CE8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0C68C95D-09F3-5F63-FE77-62200F33F8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27986-6FB6-4726-8033-6EA91535989C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41978080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A9EF594-9848-FB95-F2FB-31B7EFE0C9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9AE2DB6C-B3A6-2CC2-6D6F-09E150EB49B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2CDFCA7D-10D7-B551-9480-7299DB6EB92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6793669-095E-05FB-ED1A-EDEEDD7AEF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F99FF6-5FB5-403B-896B-059DB143E415}" type="datetimeFigureOut">
              <a:rPr lang="fr-CA" smtClean="0"/>
              <a:t>2025-11-05</a:t>
            </a:fld>
            <a:endParaRPr lang="fr-CA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30A7A826-28F2-6978-90A4-72524E9070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0B1732DE-9841-E004-FAAE-CD6CAA1AFB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27986-6FB6-4726-8033-6EA91535989C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6795064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5BDB159-94C3-A67C-FDFB-D7AFCD8376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E9894C42-A540-20CA-EF06-7930124FD07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CA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8ABBC026-C26A-5E53-75B9-8F9F2B9310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620E27D-DB2D-B49E-BAE9-FE88F51E8C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F99FF6-5FB5-403B-896B-059DB143E415}" type="datetimeFigureOut">
              <a:rPr lang="fr-CA" smtClean="0"/>
              <a:t>2025-11-05</a:t>
            </a:fld>
            <a:endParaRPr lang="fr-CA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0675C095-1C65-E19E-DF15-6288DB5658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70BAB3D-ED7D-6501-C336-AF4F5A1EB6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27986-6FB6-4726-8033-6EA91535989C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40303093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4C005DCC-B291-8F75-6420-5A429C904F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655EE69-7D09-8DF2-7D16-509EAFBCDD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02F405E-1210-F40D-A141-1E1A8E85316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2F99FF6-5FB5-403B-896B-059DB143E415}" type="datetimeFigureOut">
              <a:rPr lang="fr-CA" smtClean="0"/>
              <a:t>2025-11-05</a:t>
            </a:fld>
            <a:endParaRPr lang="fr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8BD98BE-DB1B-3585-1F00-38AD788ED05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fr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949C04D-41E3-207E-4D9D-FEA528EE894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0427986-6FB6-4726-8033-6EA91535989C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3201735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e 4">
            <a:extLst>
              <a:ext uri="{FF2B5EF4-FFF2-40B4-BE49-F238E27FC236}">
                <a16:creationId xmlns:a16="http://schemas.microsoft.com/office/drawing/2014/main" id="{E2A0B11C-3AEA-8AD0-682B-7C856B98D32A}"/>
              </a:ext>
            </a:extLst>
          </p:cNvPr>
          <p:cNvGrpSpPr/>
          <p:nvPr/>
        </p:nvGrpSpPr>
        <p:grpSpPr>
          <a:xfrm>
            <a:off x="793644" y="487382"/>
            <a:ext cx="10705581" cy="5561145"/>
            <a:chOff x="864401" y="1080654"/>
            <a:chExt cx="10705581" cy="5561145"/>
          </a:xfrm>
        </p:grpSpPr>
        <p:pic>
          <p:nvPicPr>
            <p:cNvPr id="7" name="Image 6" descr="Une image contenant croquis, Dessin au trait, dessin, joint&#10;&#10;Le contenu généré par l’IA peut être incorrect.">
              <a:extLst>
                <a:ext uri="{FF2B5EF4-FFF2-40B4-BE49-F238E27FC236}">
                  <a16:creationId xmlns:a16="http://schemas.microsoft.com/office/drawing/2014/main" id="{02EFFDE8-86CE-DA32-9D19-4657675C365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352" r="17950"/>
            <a:stretch/>
          </p:blipFill>
          <p:spPr>
            <a:xfrm>
              <a:off x="864401" y="1080654"/>
              <a:ext cx="5178656" cy="4880023"/>
            </a:xfrm>
            <a:prstGeom prst="rect">
              <a:avLst/>
            </a:prstGeom>
          </p:spPr>
        </p:pic>
        <p:sp>
          <p:nvSpPr>
            <p:cNvPr id="8" name="Ellipse 7">
              <a:extLst>
                <a:ext uri="{FF2B5EF4-FFF2-40B4-BE49-F238E27FC236}">
                  <a16:creationId xmlns:a16="http://schemas.microsoft.com/office/drawing/2014/main" id="{4A0BFDEE-A753-DD45-D404-336E7E1B95D7}"/>
                </a:ext>
              </a:extLst>
            </p:cNvPr>
            <p:cNvSpPr/>
            <p:nvPr/>
          </p:nvSpPr>
          <p:spPr>
            <a:xfrm>
              <a:off x="3628162" y="2128157"/>
              <a:ext cx="161058" cy="167244"/>
            </a:xfrm>
            <a:prstGeom prst="ellipse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/>
            </a:p>
          </p:txBody>
        </p:sp>
        <p:sp>
          <p:nvSpPr>
            <p:cNvPr id="13" name="Ellipse 12">
              <a:extLst>
                <a:ext uri="{FF2B5EF4-FFF2-40B4-BE49-F238E27FC236}">
                  <a16:creationId xmlns:a16="http://schemas.microsoft.com/office/drawing/2014/main" id="{F5F8DF0B-1462-45F4-F89D-36F0972963C6}"/>
                </a:ext>
              </a:extLst>
            </p:cNvPr>
            <p:cNvSpPr/>
            <p:nvPr/>
          </p:nvSpPr>
          <p:spPr>
            <a:xfrm>
              <a:off x="4183333" y="2128157"/>
              <a:ext cx="161058" cy="167244"/>
            </a:xfrm>
            <a:prstGeom prst="ellipse">
              <a:avLst/>
            </a:prstGeom>
            <a:solidFill>
              <a:schemeClr val="accent2">
                <a:lumMod val="50000"/>
              </a:schemeClr>
            </a:solidFill>
            <a:ln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/>
            </a:p>
          </p:txBody>
        </p:sp>
        <p:sp>
          <p:nvSpPr>
            <p:cNvPr id="14" name="Ellipse 13">
              <a:extLst>
                <a:ext uri="{FF2B5EF4-FFF2-40B4-BE49-F238E27FC236}">
                  <a16:creationId xmlns:a16="http://schemas.microsoft.com/office/drawing/2014/main" id="{E5371AE9-4B5D-DA4B-C64F-74C931D43754}"/>
                </a:ext>
              </a:extLst>
            </p:cNvPr>
            <p:cNvSpPr/>
            <p:nvPr/>
          </p:nvSpPr>
          <p:spPr>
            <a:xfrm>
              <a:off x="3708691" y="3259282"/>
              <a:ext cx="161058" cy="167244"/>
            </a:xfrm>
            <a:prstGeom prst="ellipse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/>
            </a:p>
          </p:txBody>
        </p:sp>
        <p:sp>
          <p:nvSpPr>
            <p:cNvPr id="15" name="Ellipse 14">
              <a:extLst>
                <a:ext uri="{FF2B5EF4-FFF2-40B4-BE49-F238E27FC236}">
                  <a16:creationId xmlns:a16="http://schemas.microsoft.com/office/drawing/2014/main" id="{3FD7D212-BD64-C6A5-19CD-3F070A5B24F0}"/>
                </a:ext>
              </a:extLst>
            </p:cNvPr>
            <p:cNvSpPr/>
            <p:nvPr/>
          </p:nvSpPr>
          <p:spPr>
            <a:xfrm>
              <a:off x="4102804" y="3259282"/>
              <a:ext cx="161058" cy="167244"/>
            </a:xfrm>
            <a:prstGeom prst="ellipse">
              <a:avLst/>
            </a:prstGeom>
            <a:solidFill>
              <a:schemeClr val="accent5">
                <a:lumMod val="50000"/>
              </a:schemeClr>
            </a:solidFill>
            <a:ln>
              <a:solidFill>
                <a:schemeClr val="accent5">
                  <a:lumMod val="5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/>
            </a:p>
          </p:txBody>
        </p:sp>
        <p:sp>
          <p:nvSpPr>
            <p:cNvPr id="16" name="Ellipse 15">
              <a:extLst>
                <a:ext uri="{FF2B5EF4-FFF2-40B4-BE49-F238E27FC236}">
                  <a16:creationId xmlns:a16="http://schemas.microsoft.com/office/drawing/2014/main" id="{0657FB7D-CDB7-7F3F-FAF0-CCA6BF1A6F09}"/>
                </a:ext>
              </a:extLst>
            </p:cNvPr>
            <p:cNvSpPr/>
            <p:nvPr/>
          </p:nvSpPr>
          <p:spPr>
            <a:xfrm>
              <a:off x="3752235" y="4941125"/>
              <a:ext cx="161058" cy="167244"/>
            </a:xfrm>
            <a:prstGeom prst="ellipse">
              <a:avLst/>
            </a:prstGeom>
            <a:solidFill>
              <a:schemeClr val="accent6">
                <a:lumMod val="60000"/>
                <a:lumOff val="40000"/>
              </a:schemeClr>
            </a:solidFill>
            <a:ln>
              <a:solidFill>
                <a:schemeClr val="accent6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/>
            </a:p>
          </p:txBody>
        </p:sp>
        <p:sp>
          <p:nvSpPr>
            <p:cNvPr id="17" name="Ellipse 16">
              <a:extLst>
                <a:ext uri="{FF2B5EF4-FFF2-40B4-BE49-F238E27FC236}">
                  <a16:creationId xmlns:a16="http://schemas.microsoft.com/office/drawing/2014/main" id="{33D02B9E-2ADB-152F-E90A-591E6091DC40}"/>
                </a:ext>
              </a:extLst>
            </p:cNvPr>
            <p:cNvSpPr/>
            <p:nvPr/>
          </p:nvSpPr>
          <p:spPr>
            <a:xfrm>
              <a:off x="4044047" y="4941125"/>
              <a:ext cx="161058" cy="167244"/>
            </a:xfrm>
            <a:prstGeom prst="ellipse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/>
            </a:p>
          </p:txBody>
        </p:sp>
        <p:sp>
          <p:nvSpPr>
            <p:cNvPr id="18" name="Ellipse 17">
              <a:extLst>
                <a:ext uri="{FF2B5EF4-FFF2-40B4-BE49-F238E27FC236}">
                  <a16:creationId xmlns:a16="http://schemas.microsoft.com/office/drawing/2014/main" id="{FDB56445-7241-143A-25F3-D721F1E51935}"/>
                </a:ext>
              </a:extLst>
            </p:cNvPr>
            <p:cNvSpPr/>
            <p:nvPr/>
          </p:nvSpPr>
          <p:spPr>
            <a:xfrm>
              <a:off x="1585978" y="3901539"/>
              <a:ext cx="161058" cy="167244"/>
            </a:xfrm>
            <a:prstGeom prst="ellipse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/>
            </a:p>
          </p:txBody>
        </p:sp>
        <p:sp>
          <p:nvSpPr>
            <p:cNvPr id="19" name="Ellipse 18">
              <a:extLst>
                <a:ext uri="{FF2B5EF4-FFF2-40B4-BE49-F238E27FC236}">
                  <a16:creationId xmlns:a16="http://schemas.microsoft.com/office/drawing/2014/main" id="{B6AD6271-19D1-244D-76BA-B9210CF121F4}"/>
                </a:ext>
              </a:extLst>
            </p:cNvPr>
            <p:cNvSpPr/>
            <p:nvPr/>
          </p:nvSpPr>
          <p:spPr>
            <a:xfrm>
              <a:off x="2211908" y="3901539"/>
              <a:ext cx="161058" cy="167244"/>
            </a:xfrm>
            <a:prstGeom prst="ellipse">
              <a:avLst/>
            </a:prstGeom>
            <a:solidFill>
              <a:schemeClr val="accent1"/>
            </a:solidFill>
            <a:ln>
              <a:solidFill>
                <a:schemeClr val="accent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/>
            </a:p>
          </p:txBody>
        </p:sp>
        <p:sp>
          <p:nvSpPr>
            <p:cNvPr id="20" name="Ellipse 19">
              <a:extLst>
                <a:ext uri="{FF2B5EF4-FFF2-40B4-BE49-F238E27FC236}">
                  <a16:creationId xmlns:a16="http://schemas.microsoft.com/office/drawing/2014/main" id="{CD6459F4-9DB8-E565-F513-A25F166A7A84}"/>
                </a:ext>
              </a:extLst>
            </p:cNvPr>
            <p:cNvSpPr/>
            <p:nvPr/>
          </p:nvSpPr>
          <p:spPr>
            <a:xfrm>
              <a:off x="5320892" y="3901539"/>
              <a:ext cx="161058" cy="167244"/>
            </a:xfrm>
            <a:prstGeom prst="ellipse">
              <a:avLst/>
            </a:prstGeom>
            <a:solidFill>
              <a:schemeClr val="accent1"/>
            </a:solidFill>
            <a:ln>
              <a:solidFill>
                <a:schemeClr val="accent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/>
            </a:p>
          </p:txBody>
        </p:sp>
        <p:sp>
          <p:nvSpPr>
            <p:cNvPr id="21" name="Ellipse 20">
              <a:extLst>
                <a:ext uri="{FF2B5EF4-FFF2-40B4-BE49-F238E27FC236}">
                  <a16:creationId xmlns:a16="http://schemas.microsoft.com/office/drawing/2014/main" id="{4649EC2C-3CA0-05D8-7FF2-98594DEBE789}"/>
                </a:ext>
              </a:extLst>
            </p:cNvPr>
            <p:cNvSpPr/>
            <p:nvPr/>
          </p:nvSpPr>
          <p:spPr>
            <a:xfrm>
              <a:off x="5669235" y="4941125"/>
              <a:ext cx="161058" cy="167244"/>
            </a:xfrm>
            <a:prstGeom prst="ellipse">
              <a:avLst/>
            </a:prstGeom>
            <a:solidFill>
              <a:schemeClr val="accent6">
                <a:lumMod val="60000"/>
                <a:lumOff val="40000"/>
              </a:schemeClr>
            </a:solidFill>
            <a:ln>
              <a:solidFill>
                <a:schemeClr val="accent6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/>
            </a:p>
          </p:txBody>
        </p:sp>
        <p:sp>
          <p:nvSpPr>
            <p:cNvPr id="22" name="Ellipse 21">
              <a:extLst>
                <a:ext uri="{FF2B5EF4-FFF2-40B4-BE49-F238E27FC236}">
                  <a16:creationId xmlns:a16="http://schemas.microsoft.com/office/drawing/2014/main" id="{A0DC3FD0-4611-5D6A-9D6C-65BE5676339F}"/>
                </a:ext>
              </a:extLst>
            </p:cNvPr>
            <p:cNvSpPr/>
            <p:nvPr/>
          </p:nvSpPr>
          <p:spPr>
            <a:xfrm>
              <a:off x="5669235" y="3259282"/>
              <a:ext cx="161058" cy="167244"/>
            </a:xfrm>
            <a:prstGeom prst="ellipse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/>
            </a:p>
          </p:txBody>
        </p:sp>
        <p:sp>
          <p:nvSpPr>
            <p:cNvPr id="23" name="Ellipse 22">
              <a:extLst>
                <a:ext uri="{FF2B5EF4-FFF2-40B4-BE49-F238E27FC236}">
                  <a16:creationId xmlns:a16="http://schemas.microsoft.com/office/drawing/2014/main" id="{6EBEF6C8-AF8B-2356-B7A4-1A835A41B5E8}"/>
                </a:ext>
              </a:extLst>
            </p:cNvPr>
            <p:cNvSpPr/>
            <p:nvPr/>
          </p:nvSpPr>
          <p:spPr>
            <a:xfrm>
              <a:off x="5788978" y="2128157"/>
              <a:ext cx="161058" cy="167244"/>
            </a:xfrm>
            <a:prstGeom prst="ellipse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/>
            </a:p>
          </p:txBody>
        </p:sp>
        <p:sp>
          <p:nvSpPr>
            <p:cNvPr id="24" name="ZoneTexte 23">
              <a:extLst>
                <a:ext uri="{FF2B5EF4-FFF2-40B4-BE49-F238E27FC236}">
                  <a16:creationId xmlns:a16="http://schemas.microsoft.com/office/drawing/2014/main" id="{EBB7727A-8D9D-C475-BDA1-881B2CEF4F1D}"/>
                </a:ext>
              </a:extLst>
            </p:cNvPr>
            <p:cNvSpPr txBox="1"/>
            <p:nvPr/>
          </p:nvSpPr>
          <p:spPr>
            <a:xfrm>
              <a:off x="1338420" y="5723416"/>
              <a:ext cx="11811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CA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rontal </a:t>
              </a:r>
              <a:r>
                <a:rPr lang="fr-CA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iew</a:t>
              </a:r>
              <a:endParaRPr lang="fr-CA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ZoneTexte 24">
              <a:extLst>
                <a:ext uri="{FF2B5EF4-FFF2-40B4-BE49-F238E27FC236}">
                  <a16:creationId xmlns:a16="http://schemas.microsoft.com/office/drawing/2014/main" id="{2931A075-CA05-DA8A-89A6-9942D7E86D52}"/>
                </a:ext>
              </a:extLst>
            </p:cNvPr>
            <p:cNvSpPr txBox="1"/>
            <p:nvPr/>
          </p:nvSpPr>
          <p:spPr>
            <a:xfrm>
              <a:off x="3282044" y="5720441"/>
              <a:ext cx="134154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CA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osterior</a:t>
              </a:r>
              <a:r>
                <a:rPr lang="fr-CA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CA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iew</a:t>
              </a:r>
              <a:endParaRPr lang="fr-CA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ZoneTexte 25">
              <a:extLst>
                <a:ext uri="{FF2B5EF4-FFF2-40B4-BE49-F238E27FC236}">
                  <a16:creationId xmlns:a16="http://schemas.microsoft.com/office/drawing/2014/main" id="{D752B9C6-1878-E434-3F3F-80D36F9D76C5}"/>
                </a:ext>
              </a:extLst>
            </p:cNvPr>
            <p:cNvSpPr txBox="1"/>
            <p:nvPr/>
          </p:nvSpPr>
          <p:spPr>
            <a:xfrm>
              <a:off x="4967535" y="5720441"/>
              <a:ext cx="11811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CA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Lateral</a:t>
              </a:r>
              <a:r>
                <a:rPr lang="fr-CA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CA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iew</a:t>
              </a:r>
              <a:endParaRPr lang="fr-CA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Ellipse 26">
              <a:extLst>
                <a:ext uri="{FF2B5EF4-FFF2-40B4-BE49-F238E27FC236}">
                  <a16:creationId xmlns:a16="http://schemas.microsoft.com/office/drawing/2014/main" id="{B0DBEB37-4B7F-7DFF-626E-F0ABB588B9B3}"/>
                </a:ext>
              </a:extLst>
            </p:cNvPr>
            <p:cNvSpPr/>
            <p:nvPr/>
          </p:nvSpPr>
          <p:spPr>
            <a:xfrm>
              <a:off x="6887321" y="1963881"/>
              <a:ext cx="161058" cy="167244"/>
            </a:xfrm>
            <a:prstGeom prst="ellipse">
              <a:avLst/>
            </a:prstGeom>
            <a:solidFill>
              <a:schemeClr val="accent1"/>
            </a:solidFill>
            <a:ln>
              <a:solidFill>
                <a:schemeClr val="accent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/>
            </a:p>
          </p:txBody>
        </p:sp>
        <p:sp>
          <p:nvSpPr>
            <p:cNvPr id="28" name="Ellipse 27">
              <a:extLst>
                <a:ext uri="{FF2B5EF4-FFF2-40B4-BE49-F238E27FC236}">
                  <a16:creationId xmlns:a16="http://schemas.microsoft.com/office/drawing/2014/main" id="{CD4E70BD-13DD-22A7-AA65-DCCC8B870551}"/>
                </a:ext>
              </a:extLst>
            </p:cNvPr>
            <p:cNvSpPr/>
            <p:nvPr/>
          </p:nvSpPr>
          <p:spPr>
            <a:xfrm>
              <a:off x="6887321" y="2350324"/>
              <a:ext cx="161058" cy="167244"/>
            </a:xfrm>
            <a:prstGeom prst="ellipse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/>
            </a:p>
          </p:txBody>
        </p:sp>
        <p:sp>
          <p:nvSpPr>
            <p:cNvPr id="29" name="Ellipse 28">
              <a:extLst>
                <a:ext uri="{FF2B5EF4-FFF2-40B4-BE49-F238E27FC236}">
                  <a16:creationId xmlns:a16="http://schemas.microsoft.com/office/drawing/2014/main" id="{7748FCA1-A98E-1FFE-F361-52D0AD21F7BF}"/>
                </a:ext>
              </a:extLst>
            </p:cNvPr>
            <p:cNvSpPr/>
            <p:nvPr/>
          </p:nvSpPr>
          <p:spPr>
            <a:xfrm>
              <a:off x="6887321" y="2900057"/>
              <a:ext cx="161058" cy="167244"/>
            </a:xfrm>
            <a:prstGeom prst="ellipse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/>
            </a:p>
          </p:txBody>
        </p:sp>
        <p:sp>
          <p:nvSpPr>
            <p:cNvPr id="30" name="Ellipse 29">
              <a:extLst>
                <a:ext uri="{FF2B5EF4-FFF2-40B4-BE49-F238E27FC236}">
                  <a16:creationId xmlns:a16="http://schemas.microsoft.com/office/drawing/2014/main" id="{389FA323-2E85-2570-3A43-391AA24A88E0}"/>
                </a:ext>
              </a:extLst>
            </p:cNvPr>
            <p:cNvSpPr/>
            <p:nvPr/>
          </p:nvSpPr>
          <p:spPr>
            <a:xfrm>
              <a:off x="6887321" y="3286500"/>
              <a:ext cx="161058" cy="167244"/>
            </a:xfrm>
            <a:prstGeom prst="ellipse">
              <a:avLst/>
            </a:prstGeom>
            <a:solidFill>
              <a:schemeClr val="accent2">
                <a:lumMod val="50000"/>
              </a:schemeClr>
            </a:solidFill>
            <a:ln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/>
            </a:p>
          </p:txBody>
        </p:sp>
        <p:sp>
          <p:nvSpPr>
            <p:cNvPr id="31" name="Ellipse 30">
              <a:extLst>
                <a:ext uri="{FF2B5EF4-FFF2-40B4-BE49-F238E27FC236}">
                  <a16:creationId xmlns:a16="http://schemas.microsoft.com/office/drawing/2014/main" id="{8F6181D5-3110-3CF8-573F-07FD153266AA}"/>
                </a:ext>
              </a:extLst>
            </p:cNvPr>
            <p:cNvSpPr/>
            <p:nvPr/>
          </p:nvSpPr>
          <p:spPr>
            <a:xfrm>
              <a:off x="6887321" y="3835243"/>
              <a:ext cx="161058" cy="167244"/>
            </a:xfrm>
            <a:prstGeom prst="ellipse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/>
            </a:p>
          </p:txBody>
        </p:sp>
        <p:sp>
          <p:nvSpPr>
            <p:cNvPr id="32" name="Ellipse 31">
              <a:extLst>
                <a:ext uri="{FF2B5EF4-FFF2-40B4-BE49-F238E27FC236}">
                  <a16:creationId xmlns:a16="http://schemas.microsoft.com/office/drawing/2014/main" id="{89AA8D84-8FBF-8D0C-7944-3EA7BD869A74}"/>
                </a:ext>
              </a:extLst>
            </p:cNvPr>
            <p:cNvSpPr/>
            <p:nvPr/>
          </p:nvSpPr>
          <p:spPr>
            <a:xfrm>
              <a:off x="6887321" y="4220696"/>
              <a:ext cx="161058" cy="167244"/>
            </a:xfrm>
            <a:prstGeom prst="ellipse">
              <a:avLst/>
            </a:prstGeom>
            <a:solidFill>
              <a:schemeClr val="accent5">
                <a:lumMod val="50000"/>
              </a:schemeClr>
            </a:solidFill>
            <a:ln>
              <a:solidFill>
                <a:schemeClr val="accent5">
                  <a:lumMod val="5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/>
            </a:p>
          </p:txBody>
        </p:sp>
        <p:sp>
          <p:nvSpPr>
            <p:cNvPr id="33" name="Ellipse 32">
              <a:extLst>
                <a:ext uri="{FF2B5EF4-FFF2-40B4-BE49-F238E27FC236}">
                  <a16:creationId xmlns:a16="http://schemas.microsoft.com/office/drawing/2014/main" id="{17CD46A8-7DBE-FB0E-185E-3820E1AAD2A7}"/>
                </a:ext>
              </a:extLst>
            </p:cNvPr>
            <p:cNvSpPr/>
            <p:nvPr/>
          </p:nvSpPr>
          <p:spPr>
            <a:xfrm>
              <a:off x="6887321" y="4769439"/>
              <a:ext cx="161058" cy="167244"/>
            </a:xfrm>
            <a:prstGeom prst="ellipse">
              <a:avLst/>
            </a:prstGeom>
            <a:solidFill>
              <a:schemeClr val="accent6">
                <a:lumMod val="60000"/>
                <a:lumOff val="40000"/>
              </a:schemeClr>
            </a:solidFill>
            <a:ln>
              <a:solidFill>
                <a:schemeClr val="accent6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/>
            </a:p>
          </p:txBody>
        </p:sp>
        <p:sp>
          <p:nvSpPr>
            <p:cNvPr id="34" name="Ellipse 33">
              <a:extLst>
                <a:ext uri="{FF2B5EF4-FFF2-40B4-BE49-F238E27FC236}">
                  <a16:creationId xmlns:a16="http://schemas.microsoft.com/office/drawing/2014/main" id="{957DC773-0491-0CAC-3163-1E6B0987FD9D}"/>
                </a:ext>
              </a:extLst>
            </p:cNvPr>
            <p:cNvSpPr/>
            <p:nvPr/>
          </p:nvSpPr>
          <p:spPr>
            <a:xfrm>
              <a:off x="6887321" y="5154892"/>
              <a:ext cx="161058" cy="167244"/>
            </a:xfrm>
            <a:prstGeom prst="ellipse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/>
            </a:p>
          </p:txBody>
        </p:sp>
        <p:sp>
          <p:nvSpPr>
            <p:cNvPr id="35" name="ZoneTexte 34">
              <a:extLst>
                <a:ext uri="{FF2B5EF4-FFF2-40B4-BE49-F238E27FC236}">
                  <a16:creationId xmlns:a16="http://schemas.microsoft.com/office/drawing/2014/main" id="{D918D780-B2B6-2A75-A898-38C0BAB11E67}"/>
                </a:ext>
              </a:extLst>
            </p:cNvPr>
            <p:cNvSpPr txBox="1"/>
            <p:nvPr/>
          </p:nvSpPr>
          <p:spPr>
            <a:xfrm>
              <a:off x="7048379" y="1909003"/>
              <a:ext cx="17200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Left</a:t>
              </a:r>
              <a:r>
                <a:rPr lang="fr-CA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CA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high</a:t>
              </a:r>
              <a:r>
                <a:rPr lang="fr-CA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probe </a:t>
              </a:r>
            </a:p>
          </p:txBody>
        </p:sp>
        <p:sp>
          <p:nvSpPr>
            <p:cNvPr id="36" name="ZoneTexte 35">
              <a:extLst>
                <a:ext uri="{FF2B5EF4-FFF2-40B4-BE49-F238E27FC236}">
                  <a16:creationId xmlns:a16="http://schemas.microsoft.com/office/drawing/2014/main" id="{20D86CFE-8BA8-0AC9-29DF-37A4791D4818}"/>
                </a:ext>
              </a:extLst>
            </p:cNvPr>
            <p:cNvSpPr txBox="1"/>
            <p:nvPr/>
          </p:nvSpPr>
          <p:spPr>
            <a:xfrm>
              <a:off x="7048377" y="2295446"/>
              <a:ext cx="17200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ight </a:t>
              </a:r>
              <a:r>
                <a:rPr lang="fr-CA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high</a:t>
              </a:r>
              <a:r>
                <a:rPr lang="fr-CA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probe </a:t>
              </a:r>
            </a:p>
          </p:txBody>
        </p:sp>
        <p:sp>
          <p:nvSpPr>
            <p:cNvPr id="37" name="ZoneTexte 36">
              <a:extLst>
                <a:ext uri="{FF2B5EF4-FFF2-40B4-BE49-F238E27FC236}">
                  <a16:creationId xmlns:a16="http://schemas.microsoft.com/office/drawing/2014/main" id="{62951A4F-EE9B-22C3-9509-B727748437C7}"/>
                </a:ext>
              </a:extLst>
            </p:cNvPr>
            <p:cNvSpPr txBox="1"/>
            <p:nvPr/>
          </p:nvSpPr>
          <p:spPr>
            <a:xfrm>
              <a:off x="7032606" y="2845179"/>
              <a:ext cx="17200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Left</a:t>
              </a:r>
              <a:r>
                <a:rPr lang="fr-CA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CA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hest</a:t>
              </a:r>
              <a:r>
                <a:rPr lang="fr-CA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probe </a:t>
              </a:r>
            </a:p>
          </p:txBody>
        </p:sp>
        <p:sp>
          <p:nvSpPr>
            <p:cNvPr id="38" name="ZoneTexte 37">
              <a:extLst>
                <a:ext uri="{FF2B5EF4-FFF2-40B4-BE49-F238E27FC236}">
                  <a16:creationId xmlns:a16="http://schemas.microsoft.com/office/drawing/2014/main" id="{ACC82BFB-ED40-0E5D-ED4A-2620FED96B4B}"/>
                </a:ext>
              </a:extLst>
            </p:cNvPr>
            <p:cNvSpPr txBox="1"/>
            <p:nvPr/>
          </p:nvSpPr>
          <p:spPr>
            <a:xfrm>
              <a:off x="7032607" y="3237133"/>
              <a:ext cx="17200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ight </a:t>
              </a:r>
              <a:r>
                <a:rPr lang="fr-CA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hest</a:t>
              </a:r>
              <a:r>
                <a:rPr lang="fr-CA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probe </a:t>
              </a:r>
            </a:p>
          </p:txBody>
        </p:sp>
        <p:sp>
          <p:nvSpPr>
            <p:cNvPr id="39" name="ZoneTexte 38">
              <a:extLst>
                <a:ext uri="{FF2B5EF4-FFF2-40B4-BE49-F238E27FC236}">
                  <a16:creationId xmlns:a16="http://schemas.microsoft.com/office/drawing/2014/main" id="{A41B2ED6-0A1E-06CC-1F96-BE3D7802710D}"/>
                </a:ext>
              </a:extLst>
            </p:cNvPr>
            <p:cNvSpPr txBox="1"/>
            <p:nvPr/>
          </p:nvSpPr>
          <p:spPr>
            <a:xfrm>
              <a:off x="7032606" y="3777581"/>
              <a:ext cx="17200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Left</a:t>
              </a:r>
              <a:r>
                <a:rPr lang="fr-CA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CA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uttock</a:t>
              </a:r>
              <a:r>
                <a:rPr lang="fr-CA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probe </a:t>
              </a:r>
            </a:p>
          </p:txBody>
        </p:sp>
        <p:sp>
          <p:nvSpPr>
            <p:cNvPr id="40" name="ZoneTexte 39">
              <a:extLst>
                <a:ext uri="{FF2B5EF4-FFF2-40B4-BE49-F238E27FC236}">
                  <a16:creationId xmlns:a16="http://schemas.microsoft.com/office/drawing/2014/main" id="{7E5086BB-BB3E-3FF4-2D41-209ABA05D84E}"/>
                </a:ext>
              </a:extLst>
            </p:cNvPr>
            <p:cNvSpPr txBox="1"/>
            <p:nvPr/>
          </p:nvSpPr>
          <p:spPr>
            <a:xfrm>
              <a:off x="7032605" y="4160787"/>
              <a:ext cx="17200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ight </a:t>
              </a:r>
              <a:r>
                <a:rPr lang="fr-CA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uttock</a:t>
              </a:r>
              <a:r>
                <a:rPr lang="fr-CA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probe </a:t>
              </a:r>
            </a:p>
          </p:txBody>
        </p:sp>
        <p:sp>
          <p:nvSpPr>
            <p:cNvPr id="41" name="ZoneTexte 40">
              <a:extLst>
                <a:ext uri="{FF2B5EF4-FFF2-40B4-BE49-F238E27FC236}">
                  <a16:creationId xmlns:a16="http://schemas.microsoft.com/office/drawing/2014/main" id="{0AE13900-825B-5B46-1DD8-1A41696E8CA4}"/>
                </a:ext>
              </a:extLst>
            </p:cNvPr>
            <p:cNvSpPr txBox="1"/>
            <p:nvPr/>
          </p:nvSpPr>
          <p:spPr>
            <a:xfrm>
              <a:off x="7032604" y="4707283"/>
              <a:ext cx="17200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Left</a:t>
              </a:r>
              <a:r>
                <a:rPr lang="fr-CA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alf probe </a:t>
              </a:r>
            </a:p>
          </p:txBody>
        </p:sp>
        <p:sp>
          <p:nvSpPr>
            <p:cNvPr id="42" name="ZoneTexte 41">
              <a:extLst>
                <a:ext uri="{FF2B5EF4-FFF2-40B4-BE49-F238E27FC236}">
                  <a16:creationId xmlns:a16="http://schemas.microsoft.com/office/drawing/2014/main" id="{A282FD1D-3D5A-6C58-2C3C-953034713BD1}"/>
                </a:ext>
              </a:extLst>
            </p:cNvPr>
            <p:cNvSpPr txBox="1"/>
            <p:nvPr/>
          </p:nvSpPr>
          <p:spPr>
            <a:xfrm>
              <a:off x="7032603" y="5100014"/>
              <a:ext cx="17200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ight calf probe </a:t>
              </a:r>
            </a:p>
          </p:txBody>
        </p:sp>
        <p:sp>
          <p:nvSpPr>
            <p:cNvPr id="43" name="Accolade fermante 42">
              <a:extLst>
                <a:ext uri="{FF2B5EF4-FFF2-40B4-BE49-F238E27FC236}">
                  <a16:creationId xmlns:a16="http://schemas.microsoft.com/office/drawing/2014/main" id="{AE1BBBDA-0EF1-8D23-2E56-4DCB4942D9B0}"/>
                </a:ext>
              </a:extLst>
            </p:cNvPr>
            <p:cNvSpPr/>
            <p:nvPr/>
          </p:nvSpPr>
          <p:spPr>
            <a:xfrm>
              <a:off x="8669905" y="1976717"/>
              <a:ext cx="161058" cy="545724"/>
            </a:xfrm>
            <a:prstGeom prst="rightBrac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CA"/>
            </a:p>
          </p:txBody>
        </p:sp>
        <p:sp>
          <p:nvSpPr>
            <p:cNvPr id="44" name="Accolade fermante 43">
              <a:extLst>
                <a:ext uri="{FF2B5EF4-FFF2-40B4-BE49-F238E27FC236}">
                  <a16:creationId xmlns:a16="http://schemas.microsoft.com/office/drawing/2014/main" id="{95C7F27C-7B89-84A1-BAD2-683FDAE10C12}"/>
                </a:ext>
              </a:extLst>
            </p:cNvPr>
            <p:cNvSpPr/>
            <p:nvPr/>
          </p:nvSpPr>
          <p:spPr>
            <a:xfrm>
              <a:off x="8669905" y="2891174"/>
              <a:ext cx="161058" cy="545724"/>
            </a:xfrm>
            <a:prstGeom prst="rightBrac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CA" dirty="0"/>
            </a:p>
          </p:txBody>
        </p:sp>
        <p:sp>
          <p:nvSpPr>
            <p:cNvPr id="45" name="Accolade fermante 44">
              <a:extLst>
                <a:ext uri="{FF2B5EF4-FFF2-40B4-BE49-F238E27FC236}">
                  <a16:creationId xmlns:a16="http://schemas.microsoft.com/office/drawing/2014/main" id="{BB797EFD-B1C8-8F6C-382C-AC3F7E9C4D17}"/>
                </a:ext>
              </a:extLst>
            </p:cNvPr>
            <p:cNvSpPr/>
            <p:nvPr/>
          </p:nvSpPr>
          <p:spPr>
            <a:xfrm>
              <a:off x="8672139" y="3799535"/>
              <a:ext cx="161058" cy="545724"/>
            </a:xfrm>
            <a:prstGeom prst="rightBrac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CA"/>
            </a:p>
          </p:txBody>
        </p:sp>
        <p:sp>
          <p:nvSpPr>
            <p:cNvPr id="46" name="Accolade fermante 45">
              <a:extLst>
                <a:ext uri="{FF2B5EF4-FFF2-40B4-BE49-F238E27FC236}">
                  <a16:creationId xmlns:a16="http://schemas.microsoft.com/office/drawing/2014/main" id="{9ACCD3B3-723B-82A7-9FE4-2A58A64FAE3C}"/>
                </a:ext>
              </a:extLst>
            </p:cNvPr>
            <p:cNvSpPr/>
            <p:nvPr/>
          </p:nvSpPr>
          <p:spPr>
            <a:xfrm>
              <a:off x="8669905" y="4756434"/>
              <a:ext cx="161058" cy="545724"/>
            </a:xfrm>
            <a:prstGeom prst="rightBrac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CA"/>
            </a:p>
          </p:txBody>
        </p:sp>
        <p:sp>
          <p:nvSpPr>
            <p:cNvPr id="47" name="ZoneTexte 46">
              <a:extLst>
                <a:ext uri="{FF2B5EF4-FFF2-40B4-BE49-F238E27FC236}">
                  <a16:creationId xmlns:a16="http://schemas.microsoft.com/office/drawing/2014/main" id="{9994EED0-18A6-F433-E8B4-EB1F1354BBBA}"/>
                </a:ext>
              </a:extLst>
            </p:cNvPr>
            <p:cNvSpPr txBox="1"/>
            <p:nvPr/>
          </p:nvSpPr>
          <p:spPr>
            <a:xfrm>
              <a:off x="8880092" y="2018746"/>
              <a:ext cx="217714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d-third of the anterior-lateral surface of the thigh</a:t>
              </a:r>
              <a:endParaRPr lang="fr-CA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ZoneTexte 47">
              <a:extLst>
                <a:ext uri="{FF2B5EF4-FFF2-40B4-BE49-F238E27FC236}">
                  <a16:creationId xmlns:a16="http://schemas.microsoft.com/office/drawing/2014/main" id="{14DCFC1D-95D9-99A7-6FC1-CABF65021BDA}"/>
                </a:ext>
              </a:extLst>
            </p:cNvPr>
            <p:cNvSpPr txBox="1"/>
            <p:nvPr/>
          </p:nvSpPr>
          <p:spPr>
            <a:xfrm>
              <a:off x="8880093" y="3025536"/>
              <a:ext cx="26898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lacement = scapula (</a:t>
              </a:r>
              <a:r>
                <a:rPr lang="fr-CA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void</a:t>
              </a:r>
              <a:r>
                <a:rPr lang="fr-CA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CA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onvexity</a:t>
              </a:r>
              <a:r>
                <a:rPr lang="fr-CA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</a:p>
          </p:txBody>
        </p:sp>
        <p:sp>
          <p:nvSpPr>
            <p:cNvPr id="49" name="ZoneTexte 48">
              <a:extLst>
                <a:ext uri="{FF2B5EF4-FFF2-40B4-BE49-F238E27FC236}">
                  <a16:creationId xmlns:a16="http://schemas.microsoft.com/office/drawing/2014/main" id="{0B9A90E1-A6D8-5B33-B05B-B8FDCAFDD579}"/>
                </a:ext>
              </a:extLst>
            </p:cNvPr>
            <p:cNvSpPr txBox="1"/>
            <p:nvPr/>
          </p:nvSpPr>
          <p:spPr>
            <a:xfrm>
              <a:off x="8880092" y="3910838"/>
              <a:ext cx="26898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lacement = </a:t>
              </a:r>
              <a:r>
                <a:rPr lang="fr-CA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uperolateral</a:t>
              </a:r>
              <a:r>
                <a:rPr lang="fr-CA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CA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egion</a:t>
              </a:r>
              <a:endParaRPr lang="fr-CA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ZoneTexte 49">
              <a:extLst>
                <a:ext uri="{FF2B5EF4-FFF2-40B4-BE49-F238E27FC236}">
                  <a16:creationId xmlns:a16="http://schemas.microsoft.com/office/drawing/2014/main" id="{22789C7F-7F89-1FE7-B5A4-A789005AD2EB}"/>
                </a:ext>
              </a:extLst>
            </p:cNvPr>
            <p:cNvSpPr txBox="1"/>
            <p:nvPr/>
          </p:nvSpPr>
          <p:spPr>
            <a:xfrm>
              <a:off x="8880092" y="4798463"/>
              <a:ext cx="262457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wer third of the </a:t>
              </a:r>
              <a:r>
                <a:rPr lang="en-U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ostero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lateral aspect of the calf</a:t>
              </a:r>
              <a:endParaRPr lang="fr-CA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" name="ZoneTexte 1">
              <a:extLst>
                <a:ext uri="{FF2B5EF4-FFF2-40B4-BE49-F238E27FC236}">
                  <a16:creationId xmlns:a16="http://schemas.microsoft.com/office/drawing/2014/main" id="{E3D287A9-47BC-AD92-C7F2-8B174BD73663}"/>
                </a:ext>
              </a:extLst>
            </p:cNvPr>
            <p:cNvSpPr txBox="1"/>
            <p:nvPr/>
          </p:nvSpPr>
          <p:spPr>
            <a:xfrm>
              <a:off x="6806523" y="1393093"/>
              <a:ext cx="21722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400" b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be placement</a:t>
              </a:r>
            </a:p>
          </p:txBody>
        </p:sp>
        <p:sp>
          <p:nvSpPr>
            <p:cNvPr id="4" name="ZoneTexte 3">
              <a:extLst>
                <a:ext uri="{FF2B5EF4-FFF2-40B4-BE49-F238E27FC236}">
                  <a16:creationId xmlns:a16="http://schemas.microsoft.com/office/drawing/2014/main" id="{C36C36BF-19FF-EBAB-017A-3ACD93A20EE9}"/>
                </a:ext>
              </a:extLst>
            </p:cNvPr>
            <p:cNvSpPr txBox="1"/>
            <p:nvPr/>
          </p:nvSpPr>
          <p:spPr>
            <a:xfrm>
              <a:off x="1400919" y="6272467"/>
              <a:ext cx="6096000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/>
              <a:r>
                <a:rPr lang="en-US" b="1" i="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Supplementary File 1. </a:t>
              </a:r>
              <a:r>
                <a:rPr lang="en-US" b="0" i="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Illustration of probe placement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11635978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5</TotalTime>
  <Words>68</Words>
  <Application>Microsoft Office PowerPoint</Application>
  <PresentationFormat>Grand écran</PresentationFormat>
  <Paragraphs>1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riève Houle</dc:creator>
  <cp:lastModifiedBy>Mariève Houle</cp:lastModifiedBy>
  <cp:revision>1</cp:revision>
  <dcterms:created xsi:type="dcterms:W3CDTF">2025-09-29T17:37:29Z</dcterms:created>
  <dcterms:modified xsi:type="dcterms:W3CDTF">2025-11-05T13:28:14Z</dcterms:modified>
</cp:coreProperties>
</file>